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4.xml" ContentType="application/vnd.openxmlformats-officedocument.drawingml.chartshapes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drawings/drawing5.xml" ContentType="application/vnd.openxmlformats-officedocument.drawingml.chartshapes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9144000" cy="6858000" type="screen4x3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6595" autoAdjust="0"/>
  </p:normalViewPr>
  <p:slideViewPr>
    <p:cSldViewPr showGuides="1">
      <p:cViewPr>
        <p:scale>
          <a:sx n="293" d="100"/>
          <a:sy n="293" d="100"/>
        </p:scale>
        <p:origin x="7428" y="7950"/>
      </p:cViewPr>
      <p:guideLst>
        <p:guide orient="horz" pos="4063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Tesis%20vero\Tolueno\Figuras%20manuscrito%20tolueno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F:\Tesis%20vero\Tolueno\Figuras%20manuscrito%20tolueno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F:\Tesis%20vero\Tolueno\Figuras%20manuscrito%20toluen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package" Target="../embeddings/Microsoft_Excel_Worksheet2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F:\Tesis%20vero\Tolueno\Figuras%20manuscrito%20tolueno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Tesis%20vero\Tolueno\Figuras%20manuscrito%20tolueno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Tesis%20vero\Tolueno\Figuras%20manuscrito%20toluen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611839080459781"/>
          <c:y val="0.16810763888888888"/>
          <c:w val="0.68732337164750978"/>
          <c:h val="0.6664155092592593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D$4:$D$10</c:f>
                <c:numCache>
                  <c:formatCode>General</c:formatCode>
                  <c:ptCount val="7"/>
                  <c:pt idx="1">
                    <c:v>0.10479602786861875</c:v>
                  </c:pt>
                  <c:pt idx="2">
                    <c:v>0.31438808360585668</c:v>
                  </c:pt>
                  <c:pt idx="3">
                    <c:v>0.74632268866763352</c:v>
                  </c:pt>
                  <c:pt idx="4">
                    <c:v>0.58845419174621572</c:v>
                  </c:pt>
                  <c:pt idx="5">
                    <c:v>1.30195191469889</c:v>
                  </c:pt>
                  <c:pt idx="6">
                    <c:v>0.25660000000000005</c:v>
                  </c:pt>
                </c:numCache>
              </c:numRef>
            </c:plus>
            <c:minus>
              <c:numRef>
                <c:f>'Fig 7'!$D$4:$D$10</c:f>
                <c:numCache>
                  <c:formatCode>General</c:formatCode>
                  <c:ptCount val="7"/>
                  <c:pt idx="1">
                    <c:v>0.10479602786861875</c:v>
                  </c:pt>
                  <c:pt idx="2">
                    <c:v>0.31438808360585668</c:v>
                  </c:pt>
                  <c:pt idx="3">
                    <c:v>0.74632268866763352</c:v>
                  </c:pt>
                  <c:pt idx="4">
                    <c:v>0.58845419174621572</c:v>
                  </c:pt>
                  <c:pt idx="5">
                    <c:v>1.30195191469889</c:v>
                  </c:pt>
                  <c:pt idx="6">
                    <c:v>0.25660000000000005</c:v>
                  </c:pt>
                </c:numCache>
              </c:numRef>
            </c:minus>
          </c:errBars>
          <c:xVal>
            <c:numRef>
              <c:f>'Fig 7'!$B$4:$B$10</c:f>
              <c:numCache>
                <c:formatCode>General</c:formatCode>
                <c:ptCount val="7"/>
                <c:pt idx="0">
                  <c:v>0</c:v>
                </c:pt>
                <c:pt idx="1">
                  <c:v>1.0000000000000018E-4</c:v>
                </c:pt>
                <c:pt idx="2">
                  <c:v>5.0000000000000055E-4</c:v>
                </c:pt>
                <c:pt idx="3">
                  <c:v>2.0000000000000031E-3</c:v>
                </c:pt>
                <c:pt idx="4">
                  <c:v>5.0000000000000062E-3</c:v>
                </c:pt>
                <c:pt idx="5">
                  <c:v>1.0000000000000007E-2</c:v>
                </c:pt>
                <c:pt idx="6">
                  <c:v>5.0000000000000017E-2</c:v>
                </c:pt>
              </c:numCache>
            </c:numRef>
          </c:xVal>
          <c:yVal>
            <c:numRef>
              <c:f>'Fig 7'!$C$4:$C$10</c:f>
              <c:numCache>
                <c:formatCode>0.00</c:formatCode>
                <c:ptCount val="7"/>
                <c:pt idx="0">
                  <c:v>1</c:v>
                </c:pt>
                <c:pt idx="1">
                  <c:v>1.971331985001064</c:v>
                </c:pt>
                <c:pt idx="2">
                  <c:v>3.7375363516940441</c:v>
                </c:pt>
                <c:pt idx="3">
                  <c:v>6.2831296924945841</c:v>
                </c:pt>
                <c:pt idx="4">
                  <c:v>9.38553667772943</c:v>
                </c:pt>
                <c:pt idx="5">
                  <c:v>14.806361840125797</c:v>
                </c:pt>
                <c:pt idx="6">
                  <c:v>13.8500000000000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3756032"/>
        <c:axId val="154856832"/>
      </c:scatterChart>
      <c:valAx>
        <c:axId val="153756032"/>
        <c:scaling>
          <c:orientation val="minMax"/>
          <c:max val="5.0000000000000017E-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Concentration</a:t>
                </a:r>
                <a:r>
                  <a:rPr lang="es-ES" dirty="0" smtClean="0"/>
                  <a:t> (%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0.36422183908045991"/>
              <c:y val="0.91291820987654326"/>
            </c:manualLayout>
          </c:layout>
          <c:overlay val="0"/>
        </c:title>
        <c:numFmt formatCode="0.00" sourceLinked="0"/>
        <c:majorTickMark val="out"/>
        <c:minorTickMark val="none"/>
        <c:tickLblPos val="none"/>
        <c:crossAx val="154856832"/>
        <c:crosses val="autoZero"/>
        <c:crossBetween val="midCat"/>
        <c:majorUnit val="1.0000000000000007E-2"/>
      </c:valAx>
      <c:valAx>
        <c:axId val="154856832"/>
        <c:scaling>
          <c:orientation val="minMax"/>
          <c:max val="18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err="1" smtClean="0"/>
                  <a:t>Fluorescence</a:t>
                </a:r>
                <a:r>
                  <a:rPr lang="es-ES" dirty="0" smtClean="0"/>
                  <a:t> </a:t>
                </a:r>
                <a:r>
                  <a:rPr lang="es-ES" dirty="0" err="1" smtClean="0"/>
                  <a:t>induction</a:t>
                </a:r>
                <a:r>
                  <a:rPr lang="es-ES" dirty="0" smtClean="0"/>
                  <a:t> ratio (x-</a:t>
                </a:r>
                <a:r>
                  <a:rPr lang="es-ES" dirty="0" err="1" smtClean="0"/>
                  <a:t>fold</a:t>
                </a:r>
                <a:r>
                  <a:rPr lang="es-ES" dirty="0" smtClean="0"/>
                  <a:t>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8.8208429118773982E-2"/>
              <c:y val="0.11421103395061734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 b="0"/>
            </a:pPr>
            <a:endParaRPr lang="es-ES"/>
          </a:p>
        </c:txPr>
        <c:crossAx val="153756032"/>
        <c:crosses val="autoZero"/>
        <c:crossBetween val="midCat"/>
        <c:minorUnit val="0.4"/>
      </c:valAx>
      <c:spPr>
        <a:solidFill>
          <a:schemeClr val="bg1"/>
        </a:solidFill>
      </c:spPr>
    </c:plotArea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34329501915709"/>
          <c:y val="0.16849151234567902"/>
          <c:w val="0.69232222222222228"/>
          <c:h val="0.67023148148148193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I$4:$I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9491979262593126</c:v>
                  </c:pt>
                  <c:pt idx="2">
                    <c:v>0.11641594150234</c:v>
                  </c:pt>
                  <c:pt idx="3">
                    <c:v>0.87535852212196996</c:v>
                  </c:pt>
                  <c:pt idx="4">
                    <c:v>1.3828352570774285</c:v>
                  </c:pt>
                  <c:pt idx="5">
                    <c:v>3.6749255709225097</c:v>
                  </c:pt>
                  <c:pt idx="6">
                    <c:v>3.1864461205384327</c:v>
                  </c:pt>
                  <c:pt idx="7">
                    <c:v>0.70710678118654757</c:v>
                  </c:pt>
                </c:numCache>
              </c:numRef>
            </c:plus>
            <c:minus>
              <c:numRef>
                <c:f>'Fig 7'!$I$4:$I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9491979262593126</c:v>
                  </c:pt>
                  <c:pt idx="2">
                    <c:v>0.11641594150234</c:v>
                  </c:pt>
                  <c:pt idx="3">
                    <c:v>0.87535852212196996</c:v>
                  </c:pt>
                  <c:pt idx="4">
                    <c:v>1.3828352570774285</c:v>
                  </c:pt>
                  <c:pt idx="5">
                    <c:v>3.6749255709225097</c:v>
                  </c:pt>
                  <c:pt idx="6">
                    <c:v>3.1864461205384327</c:v>
                  </c:pt>
                  <c:pt idx="7">
                    <c:v>0.70710678118654757</c:v>
                  </c:pt>
                </c:numCache>
              </c:numRef>
            </c:minus>
          </c:errBars>
          <c:xVal>
            <c:numRef>
              <c:f>'Fig 7'!$G$4:$G$11</c:f>
              <c:numCache>
                <c:formatCode>0.00</c:formatCode>
                <c:ptCount val="8"/>
                <c:pt idx="0">
                  <c:v>0</c:v>
                </c:pt>
                <c:pt idx="1">
                  <c:v>5.0000000000000034E-4</c:v>
                </c:pt>
                <c:pt idx="2">
                  <c:v>8.0000000000000123E-4</c:v>
                </c:pt>
                <c:pt idx="3">
                  <c:v>1.0000000000000015E-3</c:v>
                </c:pt>
                <c:pt idx="4">
                  <c:v>1.0000000000000005E-2</c:v>
                </c:pt>
                <c:pt idx="5">
                  <c:v>0.1</c:v>
                </c:pt>
                <c:pt idx="6">
                  <c:v>0.2</c:v>
                </c:pt>
                <c:pt idx="7">
                  <c:v>0.25</c:v>
                </c:pt>
              </c:numCache>
            </c:numRef>
          </c:xVal>
          <c:yVal>
            <c:numRef>
              <c:f>'Fig 7'!$H$4:$H$11</c:f>
              <c:numCache>
                <c:formatCode>0.00</c:formatCode>
                <c:ptCount val="8"/>
                <c:pt idx="0">
                  <c:v>1</c:v>
                </c:pt>
                <c:pt idx="1">
                  <c:v>1.9305707392828015</c:v>
                </c:pt>
                <c:pt idx="2">
                  <c:v>3.00277306927764</c:v>
                </c:pt>
                <c:pt idx="3">
                  <c:v>4.4596855544519869</c:v>
                </c:pt>
                <c:pt idx="4">
                  <c:v>8.25</c:v>
                </c:pt>
                <c:pt idx="5">
                  <c:v>26.048950545855543</c:v>
                </c:pt>
                <c:pt idx="6">
                  <c:v>19.09060302091984</c:v>
                </c:pt>
                <c:pt idx="7">
                  <c:v>14.38308047579165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302592"/>
        <c:axId val="158305664"/>
      </c:scatterChart>
      <c:valAx>
        <c:axId val="158302592"/>
        <c:scaling>
          <c:orientation val="minMax"/>
          <c:max val="0.3000000000000003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Concentration</a:t>
                </a:r>
                <a:r>
                  <a:rPr lang="es-ES" dirty="0" smtClean="0"/>
                  <a:t> (%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0.32664712643678145"/>
              <c:y val="0.91221836419753055"/>
            </c:manualLayout>
          </c:layout>
          <c:overlay val="0"/>
        </c:title>
        <c:numFmt formatCode="0.00" sourceLinked="1"/>
        <c:majorTickMark val="out"/>
        <c:minorTickMark val="none"/>
        <c:tickLblPos val="none"/>
        <c:crossAx val="158305664"/>
        <c:crosses val="autoZero"/>
        <c:crossBetween val="midCat"/>
        <c:majorUnit val="0.1"/>
      </c:valAx>
      <c:valAx>
        <c:axId val="158305664"/>
        <c:scaling>
          <c:orientation val="minMax"/>
          <c:max val="3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err="1" smtClean="0"/>
                  <a:t>Fluorescence</a:t>
                </a:r>
                <a:r>
                  <a:rPr lang="es-ES" dirty="0" smtClean="0"/>
                  <a:t> </a:t>
                </a:r>
                <a:r>
                  <a:rPr lang="es-ES" dirty="0" err="1" smtClean="0"/>
                  <a:t>induction</a:t>
                </a:r>
                <a:r>
                  <a:rPr lang="es-ES" dirty="0" smtClean="0"/>
                  <a:t> ratio (x-</a:t>
                </a:r>
                <a:r>
                  <a:rPr lang="es-ES" dirty="0" err="1" smtClean="0"/>
                  <a:t>fold</a:t>
                </a:r>
                <a:r>
                  <a:rPr lang="es-ES" dirty="0" smtClean="0"/>
                  <a:t>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2.9195402298850575E-2"/>
              <c:y val="0.1145949074074074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s-ES"/>
          </a:p>
        </c:txPr>
        <c:crossAx val="158302592"/>
        <c:crosses val="autoZero"/>
        <c:crossBetween val="midCat"/>
      </c:valAx>
    </c:plotArea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4505747126437"/>
          <c:y val="0.17068749999999996"/>
          <c:w val="0.69084865900383208"/>
          <c:h val="0.66467322530864226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N$4:$N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42184207801413981</c:v>
                  </c:pt>
                  <c:pt idx="2">
                    <c:v>0.46526297700694336</c:v>
                  </c:pt>
                  <c:pt idx="3">
                    <c:v>0.60189059339235162</c:v>
                  </c:pt>
                  <c:pt idx="4">
                    <c:v>1.6834962066554533</c:v>
                  </c:pt>
                  <c:pt idx="5">
                    <c:v>4.6284300520838642</c:v>
                  </c:pt>
                  <c:pt idx="6">
                    <c:v>6.6981057484723365</c:v>
                  </c:pt>
                  <c:pt idx="7">
                    <c:v>5.3491869299223271</c:v>
                  </c:pt>
                </c:numCache>
              </c:numRef>
            </c:plus>
            <c:minus>
              <c:numRef>
                <c:f>'Fig 7'!$N$4:$N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42184207801413981</c:v>
                  </c:pt>
                  <c:pt idx="2">
                    <c:v>0.46526297700694336</c:v>
                  </c:pt>
                  <c:pt idx="3">
                    <c:v>0.60189059339235162</c:v>
                  </c:pt>
                  <c:pt idx="4">
                    <c:v>1.6834962066554533</c:v>
                  </c:pt>
                  <c:pt idx="5">
                    <c:v>4.6284300520838642</c:v>
                  </c:pt>
                  <c:pt idx="6">
                    <c:v>6.6981057484723365</c:v>
                  </c:pt>
                  <c:pt idx="7">
                    <c:v>5.3491869299223271</c:v>
                  </c:pt>
                </c:numCache>
              </c:numRef>
            </c:minus>
          </c:errBars>
          <c:xVal>
            <c:numRef>
              <c:f>'Fig 7'!$L$4:$L$11</c:f>
              <c:numCache>
                <c:formatCode>0.00</c:formatCode>
                <c:ptCount val="8"/>
                <c:pt idx="0">
                  <c:v>0</c:v>
                </c:pt>
                <c:pt idx="1">
                  <c:v>5.0000000000000034E-4</c:v>
                </c:pt>
                <c:pt idx="2">
                  <c:v>1.0000000000000015E-3</c:v>
                </c:pt>
                <c:pt idx="3">
                  <c:v>2.5000000000000035E-3</c:v>
                </c:pt>
                <c:pt idx="4">
                  <c:v>2.5000000000000001E-2</c:v>
                </c:pt>
                <c:pt idx="5">
                  <c:v>0.1</c:v>
                </c:pt>
                <c:pt idx="6">
                  <c:v>0.25</c:v>
                </c:pt>
                <c:pt idx="7">
                  <c:v>0.30000000000000032</c:v>
                </c:pt>
              </c:numCache>
            </c:numRef>
          </c:xVal>
          <c:yVal>
            <c:numRef>
              <c:f>'Fig 7'!$M$4:$M$11</c:f>
              <c:numCache>
                <c:formatCode>0.00</c:formatCode>
                <c:ptCount val="8"/>
                <c:pt idx="0">
                  <c:v>1</c:v>
                </c:pt>
                <c:pt idx="1">
                  <c:v>1.5934417969339199</c:v>
                </c:pt>
                <c:pt idx="2">
                  <c:v>2.9801794891837252</c:v>
                </c:pt>
                <c:pt idx="3">
                  <c:v>5.5263586586832485</c:v>
                </c:pt>
                <c:pt idx="4">
                  <c:v>11.077587247183946</c:v>
                </c:pt>
                <c:pt idx="5">
                  <c:v>40.260000000000012</c:v>
                </c:pt>
                <c:pt idx="6">
                  <c:v>67.351488212918284</c:v>
                </c:pt>
                <c:pt idx="7">
                  <c:v>30.40101404410828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399488"/>
        <c:axId val="181089792"/>
      </c:scatterChart>
      <c:valAx>
        <c:axId val="180399488"/>
        <c:scaling>
          <c:orientation val="minMax"/>
          <c:max val="0.3000000000000003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Concentration</a:t>
                </a:r>
                <a:r>
                  <a:rPr lang="es-ES" dirty="0" smtClean="0"/>
                  <a:t> (%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0.38284137931034506"/>
              <c:y val="0.91375578703703708"/>
            </c:manualLayout>
          </c:layout>
          <c:overlay val="0"/>
        </c:title>
        <c:numFmt formatCode="0.00" sourceLinked="1"/>
        <c:majorTickMark val="out"/>
        <c:minorTickMark val="none"/>
        <c:tickLblPos val="none"/>
        <c:spPr>
          <a:solidFill>
            <a:schemeClr val="bg1"/>
          </a:solidFill>
        </c:spPr>
        <c:crossAx val="181089792"/>
        <c:crossesAt val="0"/>
        <c:crossBetween val="midCat"/>
        <c:majorUnit val="0.1"/>
      </c:valAx>
      <c:valAx>
        <c:axId val="1810897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s-ES" dirty="0" err="1" smtClean="0"/>
                  <a:t>Fluorescence</a:t>
                </a:r>
                <a:r>
                  <a:rPr lang="es-ES" dirty="0" smtClean="0"/>
                  <a:t> </a:t>
                </a:r>
                <a:r>
                  <a:rPr lang="es-ES" dirty="0" err="1" smtClean="0"/>
                  <a:t>induction</a:t>
                </a:r>
                <a:r>
                  <a:rPr lang="es-ES" dirty="0" smtClean="0"/>
                  <a:t> ratio (x-</a:t>
                </a:r>
                <a:r>
                  <a:rPr lang="es-ES" dirty="0" err="1" smtClean="0"/>
                  <a:t>fold</a:t>
                </a:r>
                <a:r>
                  <a:rPr lang="es-ES" dirty="0" smtClean="0"/>
                  <a:t>)</a:t>
                </a:r>
                <a:endParaRPr lang="es-ES" dirty="0"/>
              </a:p>
            </c:rich>
          </c:tx>
          <c:layout>
            <c:manualLayout>
              <c:xMode val="edge"/>
              <c:yMode val="edge"/>
              <c:x val="2.8816091954022988E-3"/>
              <c:y val="0.111891203703703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s-ES"/>
          </a:p>
        </c:txPr>
        <c:crossAx val="180399488"/>
        <c:crosses val="autoZero"/>
        <c:crossBetween val="midCat"/>
      </c:valAx>
    </c:plotArea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423231138660858"/>
          <c:y val="0.12437044032144577"/>
          <c:w val="0.67412469416360465"/>
          <c:h val="0.59656565937118111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8'!$D$3:$D$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35720809806695</c:v>
                  </c:pt>
                  <c:pt idx="2">
                    <c:v>1.0356299999999981</c:v>
                  </c:pt>
                  <c:pt idx="3">
                    <c:v>0.71407679624675169</c:v>
                  </c:pt>
                  <c:pt idx="4">
                    <c:v>1.1445733554593038</c:v>
                  </c:pt>
                  <c:pt idx="5">
                    <c:v>0.8120136871463175</c:v>
                  </c:pt>
                </c:numCache>
              </c:numRef>
            </c:plus>
            <c:minus>
              <c:numRef>
                <c:f>'Fig 8'!$D$3:$D$8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935720809806695</c:v>
                  </c:pt>
                  <c:pt idx="2">
                    <c:v>1.0356299999999981</c:v>
                  </c:pt>
                  <c:pt idx="3">
                    <c:v>0.71407679624675169</c:v>
                  </c:pt>
                  <c:pt idx="4">
                    <c:v>1.1445733554593038</c:v>
                  </c:pt>
                  <c:pt idx="5">
                    <c:v>0.8120136871463175</c:v>
                  </c:pt>
                </c:numCache>
              </c:numRef>
            </c:minus>
          </c:errBars>
          <c:xVal>
            <c:numRef>
              <c:f>'Fig 8'!$B$3:$B$8</c:f>
              <c:numCache>
                <c:formatCode>0.00</c:formatCode>
                <c:ptCount val="6"/>
                <c:pt idx="0">
                  <c:v>0</c:v>
                </c:pt>
                <c:pt idx="1">
                  <c:v>0.05</c:v>
                </c:pt>
                <c:pt idx="2">
                  <c:v>0.1</c:v>
                </c:pt>
                <c:pt idx="3">
                  <c:v>0.5</c:v>
                </c:pt>
                <c:pt idx="4">
                  <c:v>1</c:v>
                </c:pt>
                <c:pt idx="5">
                  <c:v>1.5</c:v>
                </c:pt>
              </c:numCache>
            </c:numRef>
          </c:xVal>
          <c:yVal>
            <c:numRef>
              <c:f>'Fig 8'!$C$3:$C$8</c:f>
              <c:numCache>
                <c:formatCode>0.00</c:formatCode>
                <c:ptCount val="6"/>
                <c:pt idx="0">
                  <c:v>1</c:v>
                </c:pt>
                <c:pt idx="1">
                  <c:v>2.5655037585196809</c:v>
                </c:pt>
                <c:pt idx="2">
                  <c:v>7.3834932445828914</c:v>
                </c:pt>
                <c:pt idx="3">
                  <c:v>10.290540969648053</c:v>
                </c:pt>
                <c:pt idx="4">
                  <c:v>10.785396861812629</c:v>
                </c:pt>
                <c:pt idx="5">
                  <c:v>6.4362443746574574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719552"/>
        <c:axId val="179734016"/>
      </c:scatterChart>
      <c:valAx>
        <c:axId val="179719552"/>
        <c:scaling>
          <c:orientation val="minMax"/>
          <c:max val="1.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>
                    <a:latin typeface="Times New Roman" pitchFamily="18" charset="0"/>
                    <a:cs typeface="Times New Roman" pitchFamily="18" charset="0"/>
                  </a:rPr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9987408728619028"/>
              <c:y val="0.8643341326272389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79734016"/>
        <c:crosses val="autoZero"/>
        <c:crossBetween val="midCat"/>
        <c:majorUnit val="0.5"/>
      </c:valAx>
      <c:valAx>
        <c:axId val="179734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1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 b="1">
                    <a:latin typeface="Times New Roman" pitchFamily="18" charset="0"/>
                    <a:cs typeface="Times New Roman" pitchFamily="18" charset="0"/>
                  </a:rPr>
                  <a:t>Fluorescence induction ratio (x-fold)</a:t>
                </a:r>
              </a:p>
            </c:rich>
          </c:tx>
          <c:layout>
            <c:manualLayout>
              <c:xMode val="edge"/>
              <c:yMode val="edge"/>
              <c:x val="9.4078345006970557E-2"/>
              <c:y val="7.2510847560147626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 b="0"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7971955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21374445665398"/>
          <c:y val="0.12549575617283959"/>
          <c:w val="0.7197828737033376"/>
          <c:h val="0.59958179012345669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8'!$I$3:$I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9289178097596663</c:v>
                  </c:pt>
                  <c:pt idx="2">
                    <c:v>1.3378989555847078</c:v>
                  </c:pt>
                  <c:pt idx="3">
                    <c:v>0.55204394135368162</c:v>
                  </c:pt>
                  <c:pt idx="4">
                    <c:v>0.42527563607772612</c:v>
                  </c:pt>
                </c:numCache>
              </c:numRef>
            </c:plus>
            <c:minus>
              <c:numRef>
                <c:f>'Fig 8'!$I$3:$I$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29289178097596663</c:v>
                  </c:pt>
                  <c:pt idx="2">
                    <c:v>1.3378989555847078</c:v>
                  </c:pt>
                  <c:pt idx="3">
                    <c:v>0.55204394135368162</c:v>
                  </c:pt>
                  <c:pt idx="4">
                    <c:v>0.42527563607772612</c:v>
                  </c:pt>
                </c:numCache>
              </c:numRef>
            </c:minus>
          </c:errBars>
          <c:xVal>
            <c:numRef>
              <c:f>'Fig 8'!$G$3:$G$7</c:f>
              <c:numCache>
                <c:formatCode>0.00</c:formatCode>
                <c:ptCount val="5"/>
                <c:pt idx="0">
                  <c:v>0</c:v>
                </c:pt>
                <c:pt idx="1">
                  <c:v>0.1</c:v>
                </c:pt>
                <c:pt idx="2">
                  <c:v>0.5</c:v>
                </c:pt>
                <c:pt idx="3">
                  <c:v>1</c:v>
                </c:pt>
                <c:pt idx="4">
                  <c:v>1.5</c:v>
                </c:pt>
              </c:numCache>
            </c:numRef>
          </c:xVal>
          <c:yVal>
            <c:numRef>
              <c:f>'Fig 8'!$H$3:$H$7</c:f>
              <c:numCache>
                <c:formatCode>0.00</c:formatCode>
                <c:ptCount val="5"/>
                <c:pt idx="0">
                  <c:v>1</c:v>
                </c:pt>
                <c:pt idx="1">
                  <c:v>1.3427062927673248</c:v>
                </c:pt>
                <c:pt idx="2">
                  <c:v>4.9648156517140496</c:v>
                </c:pt>
                <c:pt idx="3">
                  <c:v>8.7201216748064798</c:v>
                </c:pt>
                <c:pt idx="4">
                  <c:v>8.109550727103270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0884992"/>
        <c:axId val="180886912"/>
      </c:scatterChart>
      <c:valAx>
        <c:axId val="180884992"/>
        <c:scaling>
          <c:orientation val="minMax"/>
          <c:max val="1.5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5767969348659001"/>
              <c:y val="0.86271527777777812"/>
            </c:manualLayout>
          </c:layout>
          <c:overlay val="0"/>
        </c:title>
        <c:numFmt formatCode="0.0" sourceLinked="0"/>
        <c:majorTickMark val="out"/>
        <c:minorTickMark val="none"/>
        <c:tickLblPos val="none"/>
        <c:crossAx val="180886912"/>
        <c:crosses val="autoZero"/>
        <c:crossBetween val="midCat"/>
        <c:majorUnit val="0.5"/>
      </c:valAx>
      <c:valAx>
        <c:axId val="1808869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Fluorescence induction ratio (x-fold)</a:t>
                </a:r>
              </a:p>
            </c:rich>
          </c:tx>
          <c:layout>
            <c:manualLayout>
              <c:xMode val="edge"/>
              <c:yMode val="edge"/>
              <c:x val="2.3422605363984668E-2"/>
              <c:y val="6.7075617283950631E-2"/>
            </c:manualLayout>
          </c:layout>
          <c:overlay val="0"/>
        </c:title>
        <c:numFmt formatCode="#,##0" sourceLinked="0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s-ES"/>
          </a:p>
        </c:txPr>
        <c:crossAx val="180884992"/>
        <c:crosses val="autoZero"/>
        <c:crossBetween val="midCat"/>
        <c:majorUnit val="2"/>
      </c:valAx>
    </c:plotArea>
    <c:plotVisOnly val="1"/>
    <c:dispBlanksAs val="gap"/>
    <c:showDLblsOverMax val="0"/>
  </c:chart>
  <c:txPr>
    <a:bodyPr/>
    <a:lstStyle/>
    <a:p>
      <a:pPr>
        <a:defRPr b="1"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6668422952707"/>
          <c:y val="0.12003472222222228"/>
          <c:w val="0.73172925874972083"/>
          <c:h val="0.60544058641975318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8'!$N$3:$N$14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3.3235207941358952E-2</c:v>
                  </c:pt>
                  <c:pt idx="2">
                    <c:v>0.79325858182798381</c:v>
                  </c:pt>
                  <c:pt idx="3">
                    <c:v>1.2388991931241395</c:v>
                  </c:pt>
                  <c:pt idx="4">
                    <c:v>0.22305758583970189</c:v>
                  </c:pt>
                  <c:pt idx="5">
                    <c:v>1.0639687062807544</c:v>
                  </c:pt>
                  <c:pt idx="6">
                    <c:v>2.5373284627245098</c:v>
                  </c:pt>
                  <c:pt idx="7">
                    <c:v>3.6017021653886307</c:v>
                  </c:pt>
                  <c:pt idx="8">
                    <c:v>0.15112229574643157</c:v>
                  </c:pt>
                  <c:pt idx="9">
                    <c:v>2.639899179883157</c:v>
                  </c:pt>
                  <c:pt idx="10">
                    <c:v>1.630941871888272</c:v>
                  </c:pt>
                  <c:pt idx="11">
                    <c:v>3.9897641770728196</c:v>
                  </c:pt>
                </c:numCache>
              </c:numRef>
            </c:plus>
            <c:minus>
              <c:numRef>
                <c:f>'Fig 8'!$N$3:$N$14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3.3235207941358952E-2</c:v>
                  </c:pt>
                  <c:pt idx="2">
                    <c:v>0.79325858182798381</c:v>
                  </c:pt>
                  <c:pt idx="3">
                    <c:v>1.2388991931241395</c:v>
                  </c:pt>
                  <c:pt idx="4">
                    <c:v>0.22305758583970189</c:v>
                  </c:pt>
                  <c:pt idx="5">
                    <c:v>1.0639687062807544</c:v>
                  </c:pt>
                  <c:pt idx="6">
                    <c:v>2.5373284627245098</c:v>
                  </c:pt>
                  <c:pt idx="7">
                    <c:v>3.6017021653886307</c:v>
                  </c:pt>
                  <c:pt idx="8">
                    <c:v>0.15112229574643157</c:v>
                  </c:pt>
                  <c:pt idx="9">
                    <c:v>2.639899179883157</c:v>
                  </c:pt>
                  <c:pt idx="10">
                    <c:v>1.630941871888272</c:v>
                  </c:pt>
                  <c:pt idx="11">
                    <c:v>3.9897641770728196</c:v>
                  </c:pt>
                </c:numCache>
              </c:numRef>
            </c:minus>
          </c:errBars>
          <c:xVal>
            <c:numRef>
              <c:f>'Fig 8'!$L$3:$L$14</c:f>
              <c:numCache>
                <c:formatCode>0.00</c:formatCode>
                <c:ptCount val="12"/>
                <c:pt idx="0">
                  <c:v>0</c:v>
                </c:pt>
                <c:pt idx="1">
                  <c:v>0.15000000000000019</c:v>
                </c:pt>
                <c:pt idx="2">
                  <c:v>0.5</c:v>
                </c:pt>
                <c:pt idx="3">
                  <c:v>1</c:v>
                </c:pt>
                <c:pt idx="4">
                  <c:v>1.5</c:v>
                </c:pt>
                <c:pt idx="5">
                  <c:v>2</c:v>
                </c:pt>
                <c:pt idx="6">
                  <c:v>2.5</c:v>
                </c:pt>
                <c:pt idx="7">
                  <c:v>3.5</c:v>
                </c:pt>
                <c:pt idx="8">
                  <c:v>4</c:v>
                </c:pt>
                <c:pt idx="9">
                  <c:v>4.5</c:v>
                </c:pt>
                <c:pt idx="10">
                  <c:v>5</c:v>
                </c:pt>
                <c:pt idx="11">
                  <c:v>6</c:v>
                </c:pt>
              </c:numCache>
            </c:numRef>
          </c:xVal>
          <c:yVal>
            <c:numRef>
              <c:f>'Fig 8'!$M$3:$M$14</c:f>
              <c:numCache>
                <c:formatCode>0.00</c:formatCode>
                <c:ptCount val="12"/>
                <c:pt idx="0">
                  <c:v>1</c:v>
                </c:pt>
                <c:pt idx="1">
                  <c:v>3.8423368831728948</c:v>
                </c:pt>
                <c:pt idx="2">
                  <c:v>6.5412931043231781</c:v>
                </c:pt>
                <c:pt idx="3">
                  <c:v>7.8143101269218542</c:v>
                </c:pt>
                <c:pt idx="4">
                  <c:v>10.698535700553048</c:v>
                </c:pt>
                <c:pt idx="5">
                  <c:v>11.856520642346364</c:v>
                </c:pt>
                <c:pt idx="6">
                  <c:v>14.537186283975904</c:v>
                </c:pt>
                <c:pt idx="7">
                  <c:v>19.11358143052092</c:v>
                </c:pt>
                <c:pt idx="8">
                  <c:v>26.191033240050199</c:v>
                </c:pt>
                <c:pt idx="9">
                  <c:v>32.025613102126755</c:v>
                </c:pt>
                <c:pt idx="10">
                  <c:v>32.857621021419725</c:v>
                </c:pt>
                <c:pt idx="11">
                  <c:v>30.69277500847792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370880"/>
        <c:axId val="181372800"/>
      </c:scatterChart>
      <c:valAx>
        <c:axId val="181370880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>
                    <a:latin typeface="Times New Roman" pitchFamily="18" charset="0"/>
                    <a:cs typeface="Times New Roman" pitchFamily="18" charset="0"/>
                  </a:rPr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8111685823754815"/>
              <c:y val="0.8689216820987658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 b="0" i="0"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81372800"/>
        <c:crosses val="autoZero"/>
        <c:crossBetween val="midCat"/>
        <c:majorUnit val="1"/>
      </c:valAx>
      <c:valAx>
        <c:axId val="1813728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000">
                    <a:latin typeface="Times New Roman" pitchFamily="18" charset="0"/>
                    <a:cs typeface="Times New Roman" pitchFamily="18" charset="0"/>
                  </a:rPr>
                  <a:t>Fluorescence induction ratio (x-fold)</a:t>
                </a:r>
              </a:p>
            </c:rich>
          </c:tx>
          <c:layout>
            <c:manualLayout>
              <c:xMode val="edge"/>
              <c:yMode val="edge"/>
              <c:x val="5.3217624521072815E-2"/>
              <c:y val="6.9072916666666706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81370880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593102682077469"/>
          <c:y val="8.8002415458937208E-2"/>
          <c:w val="0.6391502476736306"/>
          <c:h val="0.66619444444444476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D$4:$D$9</c:f>
                <c:numCache>
                  <c:formatCode>General</c:formatCode>
                  <c:ptCount val="6"/>
                  <c:pt idx="1">
                    <c:v>0.10479602786861875</c:v>
                  </c:pt>
                  <c:pt idx="2">
                    <c:v>0.31438808360585668</c:v>
                  </c:pt>
                  <c:pt idx="3">
                    <c:v>0.74632268866763352</c:v>
                  </c:pt>
                  <c:pt idx="4">
                    <c:v>0.58845419174621605</c:v>
                  </c:pt>
                  <c:pt idx="5">
                    <c:v>1.30195191469889</c:v>
                  </c:pt>
                </c:numCache>
              </c:numRef>
            </c:plus>
            <c:minus>
              <c:numRef>
                <c:f>'Fig 7'!$D$4:$D$9</c:f>
                <c:numCache>
                  <c:formatCode>General</c:formatCode>
                  <c:ptCount val="6"/>
                  <c:pt idx="1">
                    <c:v>0.10479602786861875</c:v>
                  </c:pt>
                  <c:pt idx="2">
                    <c:v>0.31438808360585668</c:v>
                  </c:pt>
                  <c:pt idx="3">
                    <c:v>0.74632268866763352</c:v>
                  </c:pt>
                  <c:pt idx="4">
                    <c:v>0.58845419174621605</c:v>
                  </c:pt>
                  <c:pt idx="5">
                    <c:v>1.30195191469889</c:v>
                  </c:pt>
                </c:numCache>
              </c:numRef>
            </c:minus>
          </c:errBars>
          <c:xVal>
            <c:numRef>
              <c:f>'Fig 7'!$B$4:$B$9</c:f>
              <c:numCache>
                <c:formatCode>General</c:formatCode>
                <c:ptCount val="6"/>
                <c:pt idx="0">
                  <c:v>0</c:v>
                </c:pt>
                <c:pt idx="1">
                  <c:v>1.0000000000000022E-4</c:v>
                </c:pt>
                <c:pt idx="2">
                  <c:v>5.0000000000000077E-4</c:v>
                </c:pt>
                <c:pt idx="3">
                  <c:v>2.0000000000000031E-3</c:v>
                </c:pt>
                <c:pt idx="4">
                  <c:v>5.0000000000000062E-3</c:v>
                </c:pt>
                <c:pt idx="5">
                  <c:v>1.0000000000000007E-2</c:v>
                </c:pt>
              </c:numCache>
            </c:numRef>
          </c:xVal>
          <c:yVal>
            <c:numRef>
              <c:f>'Fig 7'!$C$4:$C$9</c:f>
              <c:numCache>
                <c:formatCode>0.00</c:formatCode>
                <c:ptCount val="6"/>
                <c:pt idx="0">
                  <c:v>1</c:v>
                </c:pt>
                <c:pt idx="1">
                  <c:v>1.971331985001064</c:v>
                </c:pt>
                <c:pt idx="2">
                  <c:v>3.7375363516940441</c:v>
                </c:pt>
                <c:pt idx="3">
                  <c:v>6.2831296924945841</c:v>
                </c:pt>
                <c:pt idx="4">
                  <c:v>9.38553667772943</c:v>
                </c:pt>
                <c:pt idx="5">
                  <c:v>14.80636184012579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483392"/>
        <c:axId val="181743616"/>
      </c:scatterChart>
      <c:valAx>
        <c:axId val="181483392"/>
        <c:scaling>
          <c:orientation val="minMax"/>
          <c:max val="1.0000000000000021E-2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900">
                    <a:latin typeface="Times New Roman" pitchFamily="18" charset="0"/>
                    <a:cs typeface="Times New Roman" pitchFamily="18" charset="0"/>
                  </a:rPr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5001810143700518"/>
              <c:y val="0.858797619047619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81743616"/>
        <c:crosses val="autoZero"/>
        <c:crossBetween val="midCat"/>
      </c:valAx>
      <c:valAx>
        <c:axId val="1817436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900">
                    <a:latin typeface="Times New Roman" pitchFamily="18" charset="0"/>
                    <a:cs typeface="Times New Roman" pitchFamily="18" charset="0"/>
                  </a:rPr>
                  <a:t>Fluorescence induction ratio (x-fold)</a:t>
                </a:r>
              </a:p>
            </c:rich>
          </c:tx>
          <c:layout>
            <c:manualLayout>
              <c:xMode val="edge"/>
              <c:yMode val="edge"/>
              <c:x val="1.0100068246385331E-2"/>
              <c:y val="8.060567632850249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itchFamily="18" charset="0"/>
                <a:cs typeface="Times New Roman" pitchFamily="18" charset="0"/>
              </a:defRPr>
            </a:pPr>
            <a:endParaRPr lang="es-ES"/>
          </a:p>
        </c:txPr>
        <c:crossAx val="181483392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836948741091203"/>
          <c:y val="9.5503968253968299E-2"/>
          <c:w val="0.64810743657043057"/>
          <c:h val="0.65836507936507982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I$4:$I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9491979262593126</c:v>
                  </c:pt>
                  <c:pt idx="2">
                    <c:v>0.11641594150234</c:v>
                  </c:pt>
                  <c:pt idx="3">
                    <c:v>0.87535852212196996</c:v>
                  </c:pt>
                  <c:pt idx="4">
                    <c:v>1.3828352570774285</c:v>
                  </c:pt>
                </c:numCache>
              </c:numRef>
            </c:plus>
            <c:minus>
              <c:numRef>
                <c:f>'Fig 7'!$I$4:$I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9491979262593126</c:v>
                  </c:pt>
                  <c:pt idx="2">
                    <c:v>0.11641594150234</c:v>
                  </c:pt>
                  <c:pt idx="3">
                    <c:v>0.87535852212196996</c:v>
                  </c:pt>
                  <c:pt idx="4">
                    <c:v>1.3828352570774285</c:v>
                  </c:pt>
                </c:numCache>
              </c:numRef>
            </c:minus>
          </c:errBars>
          <c:xVal>
            <c:numRef>
              <c:f>'Fig 7'!$G$4:$G$8</c:f>
              <c:numCache>
                <c:formatCode>0.00</c:formatCode>
                <c:ptCount val="5"/>
                <c:pt idx="0">
                  <c:v>0</c:v>
                </c:pt>
                <c:pt idx="1">
                  <c:v>5.0000000000000034E-4</c:v>
                </c:pt>
                <c:pt idx="2">
                  <c:v>8.0000000000000123E-4</c:v>
                </c:pt>
                <c:pt idx="3">
                  <c:v>1.0000000000000015E-3</c:v>
                </c:pt>
                <c:pt idx="4">
                  <c:v>1.0000000000000005E-2</c:v>
                </c:pt>
              </c:numCache>
            </c:numRef>
          </c:xVal>
          <c:yVal>
            <c:numRef>
              <c:f>'Fig 7'!$H$4:$H$8</c:f>
              <c:numCache>
                <c:formatCode>0.00</c:formatCode>
                <c:ptCount val="5"/>
                <c:pt idx="0">
                  <c:v>1</c:v>
                </c:pt>
                <c:pt idx="1">
                  <c:v>1.9305707392828015</c:v>
                </c:pt>
                <c:pt idx="2">
                  <c:v>3.00277306927764</c:v>
                </c:pt>
                <c:pt idx="3">
                  <c:v>4.4596855544519869</c:v>
                </c:pt>
                <c:pt idx="4">
                  <c:v>8.2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768576"/>
        <c:axId val="181770496"/>
      </c:scatterChart>
      <c:valAx>
        <c:axId val="181768576"/>
        <c:scaling>
          <c:orientation val="minMax"/>
          <c:max val="1.0000000000000005E-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/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1474281609195415"/>
              <c:y val="0.8546626984126986"/>
            </c:manualLayout>
          </c:layout>
          <c:overlay val="0"/>
        </c:title>
        <c:numFmt formatCode="0.000" sourceLinked="0"/>
        <c:majorTickMark val="out"/>
        <c:minorTickMark val="none"/>
        <c:tickLblPos val="none"/>
        <c:crossAx val="181770496"/>
        <c:crosses val="autoZero"/>
        <c:crossBetween val="midCat"/>
        <c:majorUnit val="5.0000000000000062E-3"/>
      </c:valAx>
      <c:valAx>
        <c:axId val="1817704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Fluorescence induction ratio (x-fold)</a:t>
                </a:r>
              </a:p>
            </c:rich>
          </c:tx>
          <c:layout>
            <c:manualLayout>
              <c:xMode val="edge"/>
              <c:yMode val="edge"/>
              <c:x val="1.4259099616858241E-2"/>
              <c:y val="8.830820105820103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900"/>
            </a:pPr>
            <a:endParaRPr lang="es-ES"/>
          </a:p>
        </c:txPr>
        <c:crossAx val="181768576"/>
        <c:crosses val="autoZero"/>
        <c:crossBetween val="midCat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799952107279696"/>
          <c:y val="9.1585317460317464E-2"/>
          <c:w val="0.65211973180076632"/>
          <c:h val="0.66972156084656109"/>
        </c:manualLayout>
      </c:layout>
      <c:scatterChart>
        <c:scatterStyle val="smoothMarker"/>
        <c:varyColors val="0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7'!$N$4:$N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42184207801413981</c:v>
                  </c:pt>
                  <c:pt idx="2">
                    <c:v>0.46526297700694336</c:v>
                  </c:pt>
                  <c:pt idx="3">
                    <c:v>0.60189059339235162</c:v>
                  </c:pt>
                  <c:pt idx="4">
                    <c:v>1.6834962066554533</c:v>
                  </c:pt>
                  <c:pt idx="5">
                    <c:v>4.6284300520838642</c:v>
                  </c:pt>
                </c:numCache>
              </c:numRef>
            </c:plus>
            <c:minus>
              <c:numRef>
                <c:f>'Fig 7'!$N$4:$N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42184207801413981</c:v>
                  </c:pt>
                  <c:pt idx="2">
                    <c:v>0.46526297700694336</c:v>
                  </c:pt>
                  <c:pt idx="3">
                    <c:v>0.60189059339235162</c:v>
                  </c:pt>
                  <c:pt idx="4">
                    <c:v>1.6834962066554533</c:v>
                  </c:pt>
                  <c:pt idx="5">
                    <c:v>4.6284300520838642</c:v>
                  </c:pt>
                </c:numCache>
              </c:numRef>
            </c:minus>
          </c:errBars>
          <c:xVal>
            <c:numRef>
              <c:f>'Fig 7'!$L$4:$L$9</c:f>
              <c:numCache>
                <c:formatCode>0.00</c:formatCode>
                <c:ptCount val="6"/>
                <c:pt idx="0">
                  <c:v>0</c:v>
                </c:pt>
                <c:pt idx="1">
                  <c:v>5.0000000000000034E-4</c:v>
                </c:pt>
                <c:pt idx="2">
                  <c:v>1.0000000000000015E-3</c:v>
                </c:pt>
                <c:pt idx="3">
                  <c:v>2.5000000000000035E-3</c:v>
                </c:pt>
                <c:pt idx="4">
                  <c:v>2.5000000000000001E-2</c:v>
                </c:pt>
                <c:pt idx="5">
                  <c:v>0.1</c:v>
                </c:pt>
              </c:numCache>
            </c:numRef>
          </c:xVal>
          <c:yVal>
            <c:numRef>
              <c:f>'Fig 7'!$M$4:$M$9</c:f>
              <c:numCache>
                <c:formatCode>0.00</c:formatCode>
                <c:ptCount val="6"/>
                <c:pt idx="0">
                  <c:v>1</c:v>
                </c:pt>
                <c:pt idx="1">
                  <c:v>1.5934417969339199</c:v>
                </c:pt>
                <c:pt idx="2">
                  <c:v>2.9801794891837252</c:v>
                </c:pt>
                <c:pt idx="3">
                  <c:v>5.5263586586832485</c:v>
                </c:pt>
                <c:pt idx="4">
                  <c:v>11.077587247183946</c:v>
                </c:pt>
                <c:pt idx="5">
                  <c:v>40.260000000000012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1819648"/>
        <c:axId val="181825920"/>
      </c:scatterChart>
      <c:valAx>
        <c:axId val="181819648"/>
        <c:scaling>
          <c:orientation val="minMax"/>
          <c:max val="0.1"/>
        </c:scaling>
        <c:delete val="0"/>
        <c:axPos val="b"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900"/>
                  <a:t>Concentration (%)</a:t>
                </a:r>
              </a:p>
            </c:rich>
          </c:tx>
          <c:layout>
            <c:manualLayout>
              <c:xMode val="edge"/>
              <c:yMode val="edge"/>
              <c:x val="0.382873563218391"/>
              <c:y val="0.85370105820105846"/>
            </c:manualLayout>
          </c:layout>
          <c:overlay val="0"/>
        </c:title>
        <c:numFmt formatCode="0.00" sourceLinked="1"/>
        <c:majorTickMark val="out"/>
        <c:minorTickMark val="none"/>
        <c:tickLblPos val="none"/>
        <c:crossAx val="181825920"/>
        <c:crosses val="autoZero"/>
        <c:crossBetween val="midCat"/>
      </c:valAx>
      <c:valAx>
        <c:axId val="1818259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Fluorescence induction ratio (x-fold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crossAx val="181819648"/>
        <c:crosses val="autoZero"/>
        <c:crossBetween val="midCat"/>
        <c:majorUnit val="10"/>
      </c:valAx>
    </c:plotArea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s-E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239</cdr:x>
      <cdr:y>0.28598</cdr:y>
    </cdr:from>
    <cdr:to>
      <cdr:x>0.64833</cdr:x>
      <cdr:y>1</cdr:y>
    </cdr:to>
    <cdr:sp macro="" textlink="">
      <cdr:nvSpPr>
        <cdr:cNvPr id="4" name="3 CuadroTexto"/>
        <cdr:cNvSpPr txBox="1"/>
      </cdr:nvSpPr>
      <cdr:spPr>
        <a:xfrm xmlns:a="http://schemas.openxmlformats.org/drawingml/2006/main">
          <a:off x="216024" y="115212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s-ES" sz="1100" dirty="0"/>
        </a:p>
      </cdr:txBody>
    </cdr:sp>
  </cdr:relSizeAnchor>
  <cdr:relSizeAnchor xmlns:cdr="http://schemas.openxmlformats.org/drawingml/2006/chartDrawing">
    <cdr:from>
      <cdr:x>0.17232</cdr:x>
      <cdr:y>0.83343</cdr:y>
    </cdr:from>
    <cdr:to>
      <cdr:x>1</cdr:x>
      <cdr:y>0.91677</cdr:y>
    </cdr:to>
    <cdr:sp macro="" textlink="">
      <cdr:nvSpPr>
        <cdr:cNvPr id="6" name="5 CuadroTexto"/>
        <cdr:cNvSpPr txBox="1"/>
      </cdr:nvSpPr>
      <cdr:spPr>
        <a:xfrm xmlns:a="http://schemas.openxmlformats.org/drawingml/2006/main">
          <a:off x="449760" y="2160240"/>
          <a:ext cx="2160245" cy="216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s-ES" sz="1000" b="0" dirty="0" smtClean="0">
              <a:latin typeface="Times New Roman" pitchFamily="18" charset="0"/>
              <a:cs typeface="Times New Roman" pitchFamily="18" charset="0"/>
            </a:rPr>
            <a:t>0.00    0.01     0.02     0.03    0.04    0.05</a:t>
          </a:r>
          <a:endParaRPr lang="es-ES" sz="10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6893</cdr:x>
      <cdr:y>0.83343</cdr:y>
    </cdr:from>
    <cdr:to>
      <cdr:x>0.94143</cdr:x>
      <cdr:y>0.91677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440904" y="2160240"/>
          <a:ext cx="2016224" cy="216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l"/>
          <a:r>
            <a:rPr lang="es-ES" sz="1000" b="0" dirty="0" smtClean="0">
              <a:latin typeface="Times New Roman" pitchFamily="18" charset="0"/>
              <a:cs typeface="Times New Roman" pitchFamily="18" charset="0"/>
            </a:rPr>
            <a:t>0.0             0.1              0.2              0.3 </a:t>
          </a:r>
          <a:endParaRPr lang="es-ES" sz="10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6554</cdr:x>
      <cdr:y>0.83343</cdr:y>
    </cdr:from>
    <cdr:to>
      <cdr:x>0.96562</cdr:x>
      <cdr:y>0.91677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432048" y="2160240"/>
          <a:ext cx="2088232" cy="216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l"/>
          <a:r>
            <a:rPr lang="es-ES" sz="1000" b="0" dirty="0" smtClean="0">
              <a:latin typeface="Times New Roman" pitchFamily="18" charset="0"/>
              <a:cs typeface="Times New Roman" pitchFamily="18" charset="0"/>
            </a:rPr>
            <a:t>0.0             0.1              0.2              0.3</a:t>
          </a:r>
          <a:endParaRPr lang="es-ES" sz="10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4134</cdr:x>
      <cdr:y>0.74679</cdr:y>
    </cdr:from>
    <cdr:to>
      <cdr:x>0.98938</cdr:x>
      <cdr:y>0.83771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368897" y="1935689"/>
          <a:ext cx="2213385" cy="2356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l"/>
          <a:r>
            <a:rPr lang="es-ES" sz="1000" b="0" dirty="0" smtClean="0">
              <a:latin typeface="Times New Roman" pitchFamily="18" charset="0"/>
              <a:cs typeface="Times New Roman" pitchFamily="18" charset="0"/>
            </a:rPr>
            <a:t> 0.0               0.5               1.0              1.5</a:t>
          </a:r>
          <a:endParaRPr lang="es-ES" sz="10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5153</cdr:x>
      <cdr:y>0.73921</cdr:y>
    </cdr:from>
    <cdr:to>
      <cdr:x>0.98634</cdr:x>
      <cdr:y>0.86385</cdr:y>
    </cdr:to>
    <cdr:sp macro="" textlink="">
      <cdr:nvSpPr>
        <cdr:cNvPr id="2" name="1 CuadroTexto"/>
        <cdr:cNvSpPr txBox="1"/>
      </cdr:nvSpPr>
      <cdr:spPr>
        <a:xfrm xmlns:a="http://schemas.openxmlformats.org/drawingml/2006/main">
          <a:off x="360040" y="1224136"/>
          <a:ext cx="1983509" cy="2063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l"/>
          <a:r>
            <a:rPr lang="es-ES" sz="900" dirty="0" smtClean="0">
              <a:latin typeface="Times New Roman" pitchFamily="18" charset="0"/>
              <a:cs typeface="Times New Roman" pitchFamily="18" charset="0"/>
            </a:rPr>
            <a:t>   0.000              0.005             0.010</a:t>
          </a:r>
          <a:endParaRPr lang="es-ES" sz="9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41AF5F-FD15-42BE-9E2C-C33FFA2AF01A}" type="datetimeFigureOut">
              <a:rPr lang="es-ES" smtClean="0"/>
              <a:t>15/06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2"/>
          </p:nvPr>
        </p:nvSpPr>
        <p:spPr>
          <a:xfrm>
            <a:off x="0" y="9377363"/>
            <a:ext cx="2946400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3"/>
          </p:nvPr>
        </p:nvSpPr>
        <p:spPr>
          <a:xfrm>
            <a:off x="3849688" y="9377363"/>
            <a:ext cx="2946400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C841A-7963-41F4-BFFC-7C59E13F4C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078813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256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553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653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31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694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905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560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069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978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215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33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8B569-F95B-40C8-87FB-98F7BA190813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75E27-89B4-4935-A578-83979DB45BCE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14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302912" y="44624"/>
            <a:ext cx="8666883" cy="6812669"/>
            <a:chOff x="302912" y="44624"/>
            <a:chExt cx="8666883" cy="6812669"/>
          </a:xfrm>
        </p:grpSpPr>
        <p:graphicFrame>
          <p:nvGraphicFramePr>
            <p:cNvPr id="4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8569480"/>
                </p:ext>
              </p:extLst>
            </p:nvPr>
          </p:nvGraphicFramePr>
          <p:xfrm>
            <a:off x="377824" y="1412776"/>
            <a:ext cx="2610000" cy="25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5 CuadroTexto"/>
            <p:cNvSpPr txBox="1"/>
            <p:nvPr/>
          </p:nvSpPr>
          <p:spPr>
            <a:xfrm>
              <a:off x="1619672" y="44624"/>
              <a:ext cx="1130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A. </a:t>
              </a:r>
              <a:r>
                <a:rPr lang="es-ES" sz="1000" b="1" i="1" dirty="0" err="1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orkumensis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SK2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539552" y="47667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8" name="3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6321923"/>
                </p:ext>
              </p:extLst>
            </p:nvPr>
          </p:nvGraphicFramePr>
          <p:xfrm>
            <a:off x="3267000" y="1412776"/>
            <a:ext cx="2610000" cy="25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9 CuadroTexto"/>
            <p:cNvSpPr txBox="1"/>
            <p:nvPr/>
          </p:nvSpPr>
          <p:spPr>
            <a:xfrm>
              <a:off x="4139952" y="44624"/>
              <a:ext cx="10136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KT2440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11" name="5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08185032"/>
                </p:ext>
              </p:extLst>
            </p:nvPr>
          </p:nvGraphicFramePr>
          <p:xfrm>
            <a:off x="6156176" y="1412776"/>
            <a:ext cx="2610000" cy="25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4" name="13 CuadroTexto"/>
            <p:cNvSpPr txBox="1"/>
            <p:nvPr/>
          </p:nvSpPr>
          <p:spPr>
            <a:xfrm>
              <a:off x="7236296" y="44624"/>
              <a:ext cx="1247457" cy="2479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DOT-T1E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18" name="1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0340013"/>
                </p:ext>
              </p:extLst>
            </p:nvPr>
          </p:nvGraphicFramePr>
          <p:xfrm>
            <a:off x="378746" y="4149080"/>
            <a:ext cx="2608156" cy="25922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9" name="2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7529945"/>
                </p:ext>
              </p:extLst>
            </p:nvPr>
          </p:nvGraphicFramePr>
          <p:xfrm>
            <a:off x="3267000" y="4149224"/>
            <a:ext cx="2610000" cy="25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0" name="3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14919963"/>
                </p:ext>
              </p:extLst>
            </p:nvPr>
          </p:nvGraphicFramePr>
          <p:xfrm>
            <a:off x="6156176" y="4149224"/>
            <a:ext cx="2610000" cy="25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1" name="20 CuadroTexto"/>
            <p:cNvSpPr txBox="1"/>
            <p:nvPr/>
          </p:nvSpPr>
          <p:spPr>
            <a:xfrm>
              <a:off x="1434972" y="4186082"/>
              <a:ext cx="11309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A. </a:t>
              </a:r>
              <a:r>
                <a:rPr lang="es-ES" sz="1000" b="1" i="1" dirty="0" err="1">
                  <a:latin typeface="Times New Roman" pitchFamily="18" charset="0"/>
                  <a:cs typeface="Times New Roman" pitchFamily="18" charset="0"/>
                </a:rPr>
                <a:t>b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orkumensis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SK2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21 CuadroTexto"/>
            <p:cNvSpPr txBox="1"/>
            <p:nvPr/>
          </p:nvSpPr>
          <p:spPr>
            <a:xfrm>
              <a:off x="4278458" y="4186082"/>
              <a:ext cx="10136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KT2440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22 CuadroTexto"/>
            <p:cNvSpPr txBox="1"/>
            <p:nvPr/>
          </p:nvSpPr>
          <p:spPr>
            <a:xfrm>
              <a:off x="7020272" y="4185228"/>
              <a:ext cx="1247457" cy="2479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b="1" i="1" dirty="0">
                  <a:latin typeface="Times New Roman" pitchFamily="18" charset="0"/>
                  <a:cs typeface="Times New Roman" pitchFamily="18" charset="0"/>
                </a:rPr>
                <a:t>P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es-ES" sz="1000" b="1" i="1" dirty="0" err="1" smtClean="0">
                  <a:latin typeface="Times New Roman" pitchFamily="18" charset="0"/>
                  <a:cs typeface="Times New Roman" pitchFamily="18" charset="0"/>
                </a:rPr>
                <a:t>putida</a:t>
              </a:r>
              <a:r>
                <a:rPr lang="es-ES" sz="1000" b="1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DOT-T1E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24 CuadroTexto"/>
            <p:cNvSpPr txBox="1"/>
            <p:nvPr/>
          </p:nvSpPr>
          <p:spPr>
            <a:xfrm>
              <a:off x="539552" y="3944089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>
            <a:xfrm>
              <a:off x="7956376" y="6580294"/>
              <a:ext cx="10134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err="1" smtClean="0">
                  <a:latin typeface="Times New Roman" pitchFamily="18" charset="0"/>
                  <a:cs typeface="Times New Roman" pitchFamily="18" charset="0"/>
                </a:rPr>
                <a:t>Suppl</a:t>
              </a:r>
              <a:r>
                <a:rPr lang="es-ES" sz="1200" b="1" dirty="0" smtClean="0">
                  <a:latin typeface="Times New Roman" pitchFamily="18" charset="0"/>
                  <a:cs typeface="Times New Roman" pitchFamily="18" charset="0"/>
                </a:rPr>
                <a:t>. Fig. </a:t>
              </a:r>
              <a:r>
                <a:rPr lang="es-ES" sz="1200" b="1" dirty="0" smtClean="0">
                  <a:latin typeface="Times New Roman" pitchFamily="18" charset="0"/>
                  <a:cs typeface="Times New Roman" pitchFamily="18" charset="0"/>
                </a:rPr>
                <a:t>1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5" name="2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33642882"/>
                </p:ext>
              </p:extLst>
            </p:nvPr>
          </p:nvGraphicFramePr>
          <p:xfrm>
            <a:off x="1115616" y="332656"/>
            <a:ext cx="2088232" cy="151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9" name="4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0327471"/>
                </p:ext>
              </p:extLst>
            </p:nvPr>
          </p:nvGraphicFramePr>
          <p:xfrm>
            <a:off x="3924160" y="332656"/>
            <a:ext cx="2088000" cy="151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2" name="6 Gráfico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95419624"/>
                </p:ext>
              </p:extLst>
            </p:nvPr>
          </p:nvGraphicFramePr>
          <p:xfrm>
            <a:off x="6804248" y="332656"/>
            <a:ext cx="2088000" cy="151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32" name="1 CuadroTexto"/>
            <p:cNvSpPr txBox="1"/>
            <p:nvPr/>
          </p:nvSpPr>
          <p:spPr>
            <a:xfrm>
              <a:off x="4212192" y="1440354"/>
              <a:ext cx="1743277" cy="1884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s-ES" sz="900" dirty="0" smtClean="0">
                  <a:latin typeface="Times New Roman" pitchFamily="18" charset="0"/>
                  <a:cs typeface="Times New Roman" pitchFamily="18" charset="0"/>
                </a:rPr>
                <a:t>   0.000              0.005             0.010</a:t>
              </a:r>
              <a:endParaRPr lang="es-E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1 CuadroTexto"/>
            <p:cNvSpPr txBox="1"/>
            <p:nvPr/>
          </p:nvSpPr>
          <p:spPr>
            <a:xfrm>
              <a:off x="7149203" y="1440354"/>
              <a:ext cx="1743277" cy="188446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s-ES" sz="900" dirty="0" smtClean="0">
                  <a:latin typeface="Times New Roman" pitchFamily="18" charset="0"/>
                  <a:cs typeface="Times New Roman" pitchFamily="18" charset="0"/>
                </a:rPr>
                <a:t>   0.00                 0.05                0.10</a:t>
              </a:r>
              <a:endParaRPr lang="es-ES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37 Rectángulo redondeado"/>
            <p:cNvSpPr/>
            <p:nvPr/>
          </p:nvSpPr>
          <p:spPr>
            <a:xfrm>
              <a:off x="971600" y="2060848"/>
              <a:ext cx="576064" cy="1479656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39" name="38 Conector recto de flecha"/>
            <p:cNvCxnSpPr>
              <a:stCxn id="38" idx="0"/>
            </p:cNvCxnSpPr>
            <p:nvPr/>
          </p:nvCxnSpPr>
          <p:spPr>
            <a:xfrm flipV="1">
              <a:off x="1259632" y="1844824"/>
              <a:ext cx="144016" cy="216024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43 Rectángulo redondeado"/>
            <p:cNvSpPr/>
            <p:nvPr/>
          </p:nvSpPr>
          <p:spPr>
            <a:xfrm>
              <a:off x="3563888" y="2852936"/>
              <a:ext cx="432048" cy="936104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45" name="44 Conector recto de flecha"/>
            <p:cNvCxnSpPr/>
            <p:nvPr/>
          </p:nvCxnSpPr>
          <p:spPr>
            <a:xfrm flipV="1">
              <a:off x="3923928" y="1844824"/>
              <a:ext cx="288032" cy="1011624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48 Rectángulo redondeado"/>
            <p:cNvSpPr/>
            <p:nvPr/>
          </p:nvSpPr>
          <p:spPr>
            <a:xfrm>
              <a:off x="6444208" y="2564904"/>
              <a:ext cx="1008112" cy="1224136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50" name="49 Conector recto de flecha"/>
            <p:cNvCxnSpPr>
              <a:stCxn id="49" idx="0"/>
            </p:cNvCxnSpPr>
            <p:nvPr/>
          </p:nvCxnSpPr>
          <p:spPr>
            <a:xfrm flipV="1">
              <a:off x="6948264" y="1844824"/>
              <a:ext cx="504056" cy="72008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ot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1 CuadroTexto"/>
            <p:cNvSpPr txBox="1"/>
            <p:nvPr/>
          </p:nvSpPr>
          <p:spPr>
            <a:xfrm>
              <a:off x="846448" y="6067896"/>
              <a:ext cx="2213384" cy="288032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s-ES" sz="1000" dirty="0" smtClean="0">
                  <a:latin typeface="Times New Roman" pitchFamily="18" charset="0"/>
                  <a:cs typeface="Times New Roman" pitchFamily="18" charset="0"/>
                </a:rPr>
                <a:t>  0.0             0.5              1.0             1.5</a:t>
              </a:r>
              <a:endParaRPr lang="es-E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28 CuadroTexto"/>
            <p:cNvSpPr txBox="1"/>
            <p:nvPr/>
          </p:nvSpPr>
          <p:spPr>
            <a:xfrm rot="16200000">
              <a:off x="132065" y="2493469"/>
              <a:ext cx="6494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err="1" smtClean="0">
                  <a:latin typeface="Times New Roman" pitchFamily="18" charset="0"/>
                  <a:cs typeface="Times New Roman" pitchFamily="18" charset="0"/>
                </a:rPr>
                <a:t>Petrol</a:t>
              </a:r>
              <a:endParaRPr lang="es-E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30 CuadroTexto"/>
            <p:cNvSpPr txBox="1"/>
            <p:nvPr/>
          </p:nvSpPr>
          <p:spPr>
            <a:xfrm rot="16200000">
              <a:off x="134437" y="5112016"/>
              <a:ext cx="6447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latin typeface="Times New Roman" pitchFamily="18" charset="0"/>
                  <a:cs typeface="Times New Roman" pitchFamily="18" charset="0"/>
                </a:rPr>
                <a:t>Diesel</a:t>
              </a:r>
              <a:endParaRPr lang="es-E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01241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</TotalTime>
  <Words>141</Words>
  <Application>Microsoft Office PowerPoint</Application>
  <PresentationFormat>Presentación en pantalla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Segura Carnicero</dc:creator>
  <cp:lastModifiedBy>a</cp:lastModifiedBy>
  <cp:revision>28</cp:revision>
  <cp:lastPrinted>2016-01-28T13:50:12Z</cp:lastPrinted>
  <dcterms:created xsi:type="dcterms:W3CDTF">2016-01-28T11:33:09Z</dcterms:created>
  <dcterms:modified xsi:type="dcterms:W3CDTF">2016-06-15T08:08:41Z</dcterms:modified>
</cp:coreProperties>
</file>